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E2CA21-A0EE-44D8-9210-C2B005B0F403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89EA68-982F-40F1-A14A-D43A3293EF0E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4E12B-081B-4589-9625-E3349D5D03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04FEA6-D37D-421F-A58C-69587374B1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9C17D-F55B-47B2-A399-BD86F77FB4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036C82-004D-4B38-8E2C-07D27FF783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1C86CF-751F-4FEE-8AD7-9B2BE2088B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C9625-3FC3-4690-A5FD-A9D6C58D06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02568-37F5-4DB5-8E6F-BD21EC2D84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640E9C-6A71-436D-93FE-92E65DCF78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2D0A9-CD74-479B-88F0-CB7FEA36B3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0B02F-FFC2-4448-9BB6-986FA8FC6B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C8AF0-7CEF-4753-98DE-B8043B69C6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02ED0-CFD5-4990-8A4E-B02DCC97E6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90745D-0F72-4466-BFAE-303F7918AC82}" type="slidenum">
              <a:rPr b="0" lang="pt-B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Imagem 29" descr=""/>
          <p:cNvPicPr/>
          <p:nvPr/>
        </p:nvPicPr>
        <p:blipFill>
          <a:blip r:embed="rId1"/>
          <a:stretch/>
        </p:blipFill>
        <p:spPr>
          <a:xfrm>
            <a:off x="108000" y="1079640"/>
            <a:ext cx="8896320" cy="327024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3"/>
          <p:cNvSpPr/>
          <p:nvPr/>
        </p:nvSpPr>
        <p:spPr>
          <a:xfrm>
            <a:off x="0" y="5518080"/>
            <a:ext cx="9144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S2:</a:t>
            </a:r>
            <a:r>
              <a:rPr b="1" lang="en-US" sz="900" spc="-1" strike="noStrike">
                <a:solidFill>
                  <a:srgbClr val="4f81bd"/>
                </a:solidFill>
                <a:latin typeface="Times New Roman"/>
                <a:ea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The CNAG_01169 gene encodes an aspartyl aminopeptidase belonging to the M18 family, the region underlined in green matches the motif that identifies this protein as M18 family member (http://www.ebi.ac.uk/interpro/protein/J9VNI6). Residues in red identify catalytic sites bound to Zinc, tool BLAST, NCBI Conserved Domains (http://www.ncbi.nlm.nih.gov/Structure/cdd /wrpsb.cgi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9T10:58:13Z</dcterms:created>
  <dc:creator>Marcelo</dc:creator>
  <dc:description/>
  <dc:language>en-US</dc:language>
  <cp:lastModifiedBy>Marcelo</cp:lastModifiedBy>
  <dcterms:modified xsi:type="dcterms:W3CDTF">2016-12-20T15:59:22Z</dcterms:modified>
  <cp:revision>17</cp:revision>
  <dc:subject/>
  <dc:title>Slide 1</dc:title>
</cp:coreProperties>
</file>